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5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3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067BE7-7CB3-59B3-8B79-95BB6EECF2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0625598-A440-E785-8050-519193E432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BE613E-703F-1FA6-CEBC-C5ED10E8B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546D68-1B53-5CB4-F7EC-3FCE3857A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92BA62-B54E-55C8-730F-614D5517B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209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316762-6616-748B-57BB-60F74838E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399C8F5-C888-D058-7447-18E01C0E09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86BE48-35C9-E293-E326-29C684E43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5E0BBF-9912-C4C2-1A9C-BFE14F0BF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66E94C-7064-2395-9184-1EE22D5A8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22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5399D9C-6BD3-1668-44FE-2DBC39D875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AD42166-EDEC-F016-0DE3-260E7E247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C07550-D23C-C901-A8F3-60204F79F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B93193-F18A-4066-320E-77FE5892D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B4844D-D855-40F7-D919-0E354823D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0007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6990EB-721A-B7F0-C051-1017F7983B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C2B93AA-C131-064A-DF6B-7E39657FFB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742958-40DC-4635-7BE4-0E0FEC61B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2E3CFF-FE0C-CC3C-E25D-1DD08BBE6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9D61FB-9C4B-D088-E179-2D09D18B5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976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2B2E15-B506-08EC-06D4-5AA5F7743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80D5D1-A1D5-F83D-44EF-FE1E1D0166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710EE1-0965-A189-E7B6-F28BDEAA7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63CF11-AC27-9D00-28F7-A0839D93B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06F4D7-8951-77EA-3CE0-3BAEF43BE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7590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EFB76A-3F25-DF80-34F9-A4F778CF35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F9640B-2606-8BC1-0C41-ADC98E02E5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7FAA5D-DC9C-6912-D349-846E184968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7AEB64-7C7C-613B-0B3F-AB02206E6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97105FF-358A-6B63-B717-FF00953B1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50B9A3-55C8-9DFD-C795-4CB6F9060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641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3049D2-467F-EE08-B645-229F265B9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07A280-A0E0-595E-CA4D-A1971D79E6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1F556C6-104A-2AAF-FC67-430F84B2BE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8AF164A-B160-0652-7F7D-DE2AD627A1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C01D646-892C-F4E4-6C49-836B6B8B17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784D260-2C5F-3D7A-416E-7ED235CBC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0056822-279E-A10A-F42B-1C3E48C64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BC4C7EC-C800-F460-F6ED-7A285C3E8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8933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59CFF1-8E03-B9C2-FF44-F8E61EC4A3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FAD4F89-1575-A044-6138-EB2F36524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43B93E2-C5E4-8299-3BA5-391111523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5CDE2F0-D124-D547-5973-10E3F8274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318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3F3ACDA-C456-B5FC-3293-41879C7B5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74FC85F-9126-E1F3-07E2-DE7382D46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86510B9-85F7-4178-8318-DEE2E9645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776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9C1D8D-4B90-F9EE-D9F3-CCC5AAF98F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2F7752-6212-E2E9-EAF5-82CCB41687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C7EE1DD-139B-C0AB-BC5D-C0F129941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E21E483-390D-36A5-D378-313353C31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1B21C5-B1C4-19C4-CE85-51FFDBF1F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1C9846-3510-230B-EEC2-F3ECEB184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762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0ACF53-12E0-D0F3-F50C-073FA26FD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F08454C-09A4-C53F-4728-EADC44B0A8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348B74D-29C2-0F56-41A5-52A8DDE29C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BD36570-17E0-13FF-47EB-987BA36D7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A37A1C-7C34-4DDA-B608-4D3D9112A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7FD1A4-8581-8A26-1481-F514B6152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363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57E1A6D-78F2-A45F-FD0A-30B826873B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C78746-564D-2AA1-6114-DBAF6E8D63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E8A621-7DEA-94DF-4B9C-B01F163CC3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86C0C9-8039-44ED-83F4-510091232457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044CCA-00B1-8154-281D-104A803AC1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6843A9-E65F-F9D3-2256-17A2793810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2A8914-5881-44AA-935C-0A43012964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91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hyperlink" Target="supplement%20video.mp4" TargetMode="External"/><Relationship Id="rId2" Type="http://schemas.openxmlformats.org/officeDocument/2006/relationships/hyperlink" Target="file:///D:\&#21271;&#24037;&#22823;\&#25991;&#31456;&#25237;&#31295;\&#25237;&#31295;Affibody\IJBM\Supplement%20video.AVI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A98ED34-CBAC-B2FC-8E20-0BB9C44FE020}"/>
              </a:ext>
            </a:extLst>
          </p:cNvPr>
          <p:cNvSpPr txBox="1"/>
          <p:nvPr/>
        </p:nvSpPr>
        <p:spPr>
          <a:xfrm>
            <a:off x="949147" y="693982"/>
            <a:ext cx="9504274" cy="14587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orting information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struction of Anti-HER2 Affibody-Directed CAR-NK and Its Synergistic Effects with Doxorubicin-loaded Nanodrug Against HER2-Positive Breast Cancer</a:t>
            </a:r>
            <a:endParaRPr lang="zh-CN" altLang="zh-CN" sz="16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1B5A66D-2123-D12C-0C92-E480CDDD82E6}"/>
              </a:ext>
            </a:extLst>
          </p:cNvPr>
          <p:cNvSpPr txBox="1"/>
          <p:nvPr/>
        </p:nvSpPr>
        <p:spPr>
          <a:xfrm>
            <a:off x="946710" y="2411766"/>
            <a:ext cx="10330891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uesong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e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zh-CN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†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aoyua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ang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†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Qing Liu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Xiaofei Zhang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Hao Liang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*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unqing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Jia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*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ang Sheng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*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buNone/>
            </a:pP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eijing International Science and Technology, Cooperation Base of Antivirus Drug, College of Chemistry and Life Science, Beijing University of Technology, Beijing, 100124, China </a:t>
            </a:r>
          </a:p>
          <a:p>
            <a:pPr algn="l">
              <a:lnSpc>
                <a:spcPct val="150000"/>
              </a:lnSpc>
              <a:buNone/>
            </a:pP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partment of Hepatobiliary Surgery, The Second Affiliated Hospital of Jiaxing University, Jiaxing, Zhejiang 31400, China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†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uesong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e and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aoyua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ang share the first authorship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buNone/>
            </a:pPr>
            <a:r>
              <a:rPr lang="zh-CN" altLang="zh-CN" sz="1800" kern="100" baseline="30000" dirty="0">
                <a:effectLst/>
                <a:ea typeface="MS Gothic" panose="020B0609070205080204" pitchFamily="49" charset="-128"/>
                <a:cs typeface="MS Gothic" panose="020B0609070205080204" pitchFamily="49" charset="-128"/>
              </a:rPr>
              <a:t>∗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orresponding author: 13426150365@163.com (Hao Liang); runqingjia@bjut.edu.cn (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unqing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Jia); shengwang@bjut.edu.cn (Wang Sheng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241649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41AA156-3B9C-AF42-D11C-C115AECF4DB9}"/>
              </a:ext>
            </a:extLst>
          </p:cNvPr>
          <p:cNvSpPr txBox="1"/>
          <p:nvPr/>
        </p:nvSpPr>
        <p:spPr>
          <a:xfrm>
            <a:off x="765545" y="5043537"/>
            <a:ext cx="11153553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.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mmunofluorescence analysis and quantitative assessment of CAR expression in NK-92MI cells.(A) Representative immunofluorescence images showing surface expression of CAR in </a:t>
            </a:r>
            <a:r>
              <a:rPr lang="en-US" altLang="zh-CN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Fv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AR-NK, Affi1 CAR-NK, and Affi2 CAR-NK cells compared with NK-92MI cells. Cells were stained with a FITC-conjugated anti-</a:t>
            </a:r>
            <a:r>
              <a:rPr lang="en-US" altLang="zh-CN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yc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tibody to detect CAR expression. Scale bar = 50 µm. (B) Percentage of </a:t>
            </a:r>
            <a:r>
              <a:rPr lang="en-US" altLang="zh-CN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yc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positive cells among the indicated NK cell populations, demonstrating transduction efficiency. (C) Quantification of relative fluorescence intensity (fold change over NK-92MI cells) demonstrating CAR surface expression levels. Data are shown as mean ± SD (n = 3). Statistical significance was determined using one-way ANOVA followed by Tukey’s post hoc test. ****P &lt; 0.0001; ns, not significant.</a:t>
            </a:r>
            <a:endParaRPr lang="zh-CN" altLang="en-US" sz="1600" dirty="0"/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DEEE8AB0-92A7-57F2-9CE4-7E85B6BCE38F}"/>
              </a:ext>
            </a:extLst>
          </p:cNvPr>
          <p:cNvGrpSpPr/>
          <p:nvPr/>
        </p:nvGrpSpPr>
        <p:grpSpPr>
          <a:xfrm>
            <a:off x="1271320" y="125402"/>
            <a:ext cx="10006890" cy="4922561"/>
            <a:chOff x="1486005" y="125402"/>
            <a:chExt cx="10006890" cy="4922561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18D381CA-C10A-43BC-EEF2-8C31EAAE7D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86005" y="249995"/>
              <a:ext cx="4035902" cy="4797968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D97E646-843C-66AD-1993-8F2A39ECCB86}"/>
                </a:ext>
              </a:extLst>
            </p:cNvPr>
            <p:cNvSpPr txBox="1"/>
            <p:nvPr/>
          </p:nvSpPr>
          <p:spPr>
            <a:xfrm>
              <a:off x="1512044" y="125402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332AF48-B730-53C2-8C50-2B0C79F369E5}"/>
                </a:ext>
              </a:extLst>
            </p:cNvPr>
            <p:cNvSpPr txBox="1"/>
            <p:nvPr/>
          </p:nvSpPr>
          <p:spPr>
            <a:xfrm>
              <a:off x="5568536" y="125402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1C363780-6D81-F665-9623-8FD0795054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54623" y="525904"/>
              <a:ext cx="2938272" cy="4360164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016C039-5475-E6F1-1431-B654269E94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6967" y="1319485"/>
              <a:ext cx="2945892" cy="3582924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58D662A-4183-D2F7-CF4F-EF45894C8B00}"/>
                </a:ext>
              </a:extLst>
            </p:cNvPr>
            <p:cNvSpPr txBox="1"/>
            <p:nvPr/>
          </p:nvSpPr>
          <p:spPr>
            <a:xfrm>
              <a:off x="8225591" y="125402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454014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110953F-3914-2289-E9FF-ADE242D0DA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8000" y="1860638"/>
            <a:ext cx="5285105" cy="214185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9304E49-5436-499C-0445-079DE3883362}"/>
              </a:ext>
            </a:extLst>
          </p:cNvPr>
          <p:cNvSpPr txBox="1"/>
          <p:nvPr/>
        </p:nvSpPr>
        <p:spPr>
          <a:xfrm>
            <a:off x="1973275" y="4666780"/>
            <a:ext cx="893368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2. Hyaluronic acid-chitosan nano-doxorubicin drug characterization (A) DLS detection of DNP size (B) Observation of DNP morphology by transmission electron microscope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cale bar 100nm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5586107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55966A1-D06F-2F08-041B-B1757453B7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7811" y="1378698"/>
            <a:ext cx="5859304" cy="2264271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1FE5A21-0B16-0F67-C6A6-076A8F5F912D}"/>
              </a:ext>
            </a:extLst>
          </p:cNvPr>
          <p:cNvSpPr txBox="1"/>
          <p:nvPr/>
        </p:nvSpPr>
        <p:spPr>
          <a:xfrm>
            <a:off x="1746505" y="4104041"/>
            <a:ext cx="10162640" cy="1991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  <a:buNone/>
            </a:pP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Study on the toxicity of DOX and DNP to SKBR3 (A) Detection of half lethal dose (IC 50) after DOX and DNP are incubated with SKBR3 for a certain period of time (24h, 48h, 72h) (B) CCK8 method was used to detect the effect of DOX, DNP and SKBR3 co-incubation at different times (24h, 48h, 72h) on cell proliferation. The drug concentration was 0.1μg/ml. Data are presented as the mean ± SD, n=3</a:t>
            </a:r>
            <a:endParaRPr lang="zh-CN" altLang="zh-CN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46465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4567CF8-21F4-8567-C66F-49EA576597C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823" t="48512" r="48366"/>
          <a:stretch>
            <a:fillRect/>
          </a:stretch>
        </p:blipFill>
        <p:spPr>
          <a:xfrm>
            <a:off x="5039461" y="1085328"/>
            <a:ext cx="2961640" cy="262445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B45BE3B-7714-B0ED-4911-337D43F695AD}"/>
              </a:ext>
            </a:extLst>
          </p:cNvPr>
          <p:cNvSpPr txBox="1"/>
          <p:nvPr/>
        </p:nvSpPr>
        <p:spPr>
          <a:xfrm>
            <a:off x="3055926" y="4135724"/>
            <a:ext cx="8428938" cy="10069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  <a:buNone/>
            </a:pP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 Changes in body weight of mice after drug treatment in different groups. Data are presented as the mean ± SD, n=5</a:t>
            </a:r>
            <a:endParaRPr lang="zh-CN" altLang="zh-CN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891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63B7C09-7805-98E5-30AF-FB1313EEAF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8090" y="545424"/>
            <a:ext cx="5200339" cy="386519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F77ABB1-D114-F649-CB89-EAE0C9CD019C}"/>
              </a:ext>
            </a:extLst>
          </p:cNvPr>
          <p:cNvSpPr txBox="1"/>
          <p:nvPr/>
        </p:nvSpPr>
        <p:spPr>
          <a:xfrm>
            <a:off x="3143706" y="4826736"/>
            <a:ext cx="760232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5. Flow cytometry detection of residual NK (CD45+CD56+) in mice after treatment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4351918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>
            <a:extLst>
              <a:ext uri="{FF2B5EF4-FFF2-40B4-BE49-F238E27FC236}">
                <a16:creationId xmlns:a16="http://schemas.microsoft.com/office/drawing/2014/main" id="{FAD00BF8-2D9B-06C6-B2C2-48412094EB36}"/>
              </a:ext>
            </a:extLst>
          </p:cNvPr>
          <p:cNvGrpSpPr/>
          <p:nvPr/>
        </p:nvGrpSpPr>
        <p:grpSpPr>
          <a:xfrm>
            <a:off x="2010220" y="660313"/>
            <a:ext cx="8529532" cy="3874008"/>
            <a:chOff x="1059045" y="601451"/>
            <a:chExt cx="8529532" cy="3874008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54EBA9BD-69D2-6A4D-10C9-CC4EED061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42685" y="601451"/>
              <a:ext cx="2945892" cy="3874008"/>
            </a:xfrm>
            <a:prstGeom prst="rect">
              <a:avLst/>
            </a:prstGeom>
          </p:spPr>
        </p:pic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9FF32448-9952-9B92-11F4-AB794284AAB6}"/>
                </a:ext>
              </a:extLst>
            </p:cNvPr>
            <p:cNvGrpSpPr/>
            <p:nvPr/>
          </p:nvGrpSpPr>
          <p:grpSpPr>
            <a:xfrm>
              <a:off x="1059045" y="1095164"/>
              <a:ext cx="5308741" cy="2930573"/>
              <a:chOff x="1297584" y="904332"/>
              <a:chExt cx="5308741" cy="293057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2E49E232-804A-B842-C0F0-347D50F618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97584" y="904332"/>
                <a:ext cx="2667000" cy="290322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2B7A9D2A-8780-FD97-6FE9-580DB1B624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39325" y="931685"/>
                <a:ext cx="2667000" cy="2903220"/>
              </a:xfrm>
              <a:prstGeom prst="rect">
                <a:avLst/>
              </a:prstGeom>
            </p:spPr>
          </p:pic>
          <p:cxnSp>
            <p:nvCxnSpPr>
              <p:cNvPr id="17" name="直接箭头连接符 16">
                <a:extLst>
                  <a:ext uri="{FF2B5EF4-FFF2-40B4-BE49-F238E27FC236}">
                    <a16:creationId xmlns:a16="http://schemas.microsoft.com/office/drawing/2014/main" id="{310B3B57-4FDB-47BC-2B7A-F9AF2BA634F6}"/>
                  </a:ext>
                </a:extLst>
              </p:cNvPr>
              <p:cNvCxnSpPr/>
              <p:nvPr/>
            </p:nvCxnSpPr>
            <p:spPr>
              <a:xfrm>
                <a:off x="3212327" y="2353586"/>
                <a:ext cx="1073426" cy="95416"/>
              </a:xfrm>
              <a:prstGeom prst="straightConnector1">
                <a:avLst/>
              </a:prstGeom>
              <a:ln w="317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B964ECC8-3038-C207-F793-1594AB2A878E}"/>
                </a:ext>
              </a:extLst>
            </p:cNvPr>
            <p:cNvSpPr txBox="1"/>
            <p:nvPr/>
          </p:nvSpPr>
          <p:spPr>
            <a:xfrm>
              <a:off x="1113182" y="80440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9F02AF5-5878-66E0-CBF7-12A2C1AEC962}"/>
                </a:ext>
              </a:extLst>
            </p:cNvPr>
            <p:cNvSpPr txBox="1"/>
            <p:nvPr/>
          </p:nvSpPr>
          <p:spPr>
            <a:xfrm>
              <a:off x="6394173" y="804408"/>
              <a:ext cx="3321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68955F8A-6798-2626-CD4A-EDD385401651}"/>
              </a:ext>
            </a:extLst>
          </p:cNvPr>
          <p:cNvSpPr txBox="1"/>
          <p:nvPr/>
        </p:nvSpPr>
        <p:spPr>
          <a:xfrm>
            <a:off x="1805498" y="4621625"/>
            <a:ext cx="9491869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Gating strategy and mean fluorescence intensity (MFI) analysis of CAR expression in NK cells.(A) Flow cytometry gating strategy used to analyze CAR expression in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Fv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-NK cells. Lymphocyte populations were first identified based on FSC/SSC characteristics. The gated lymphocyte subset was subsequently assessed for surface CAR expression using a FITC-conjugated anti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. (B) Quantitative analysis of mean fluorescence intensity (MFI) of CAR surface expression among different CAR-engineered NK cells, including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Fv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-NK, Affi1 CAR-NK, Affi2 CAR-NK, and NK-92MI cells. Data are presented as mean ± SD (n = 3). Statistical significance was determined using one-way ANOVA followed by Tukey’s post hoc test. ****P &lt; 0.0001; ns, not significant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02288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B262E80-AE2E-57D3-FEDC-5DA75368E5F3}"/>
              </a:ext>
            </a:extLst>
          </p:cNvPr>
          <p:cNvSpPr txBox="1"/>
          <p:nvPr/>
        </p:nvSpPr>
        <p:spPr>
          <a:xfrm>
            <a:off x="3099817" y="3015521"/>
            <a:ext cx="6097218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buNone/>
            </a:pPr>
            <a:r>
              <a:rPr lang="en-US" altLang="zh-CN" sz="18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hlinkClick r:id="rId2"/>
              </a:rPr>
              <a:t>Supplement video.</a:t>
            </a:r>
            <a:r>
              <a:rPr lang="en-US" altLang="zh-CN" sz="18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hlinkClick r:id="rId3" action="ppaction://hlinkfile"/>
              </a:rPr>
              <a:t>MP4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B9EB927-A5D1-CA8C-7C64-1F55A2A845BC}"/>
              </a:ext>
            </a:extLst>
          </p:cNvPr>
          <p:cNvSpPr txBox="1"/>
          <p:nvPr/>
        </p:nvSpPr>
        <p:spPr>
          <a:xfrm>
            <a:off x="3055924" y="4406387"/>
            <a:ext cx="7682789" cy="10069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zh-CN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video. Live cell imaging of the killing process of Affi1 CAR-NK cells to SK-BR-3 cells</a:t>
            </a:r>
            <a:endParaRPr lang="zh-CN" altLang="zh-CN" sz="16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4036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</TotalTime>
  <Words>606</Words>
  <Application>Microsoft Office PowerPoint</Application>
  <PresentationFormat>宽屏</PresentationFormat>
  <Paragraphs>20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MS Gothic</vt:lpstr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学松 何</dc:creator>
  <cp:lastModifiedBy>学松 何</cp:lastModifiedBy>
  <cp:revision>16</cp:revision>
  <dcterms:created xsi:type="dcterms:W3CDTF">2025-08-25T05:18:48Z</dcterms:created>
  <dcterms:modified xsi:type="dcterms:W3CDTF">2025-12-19T12:46:00Z</dcterms:modified>
</cp:coreProperties>
</file>